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CA81"/>
    <a:srgbClr val="573A6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2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s1filetu11.d01.arc.local\HBR\8%20PERSONAL\Sehr%20Stierschneider%20Lab\Projekte\Running%20projects\BeetStore\Bioinformatik\unmapped_reads_analysis\summary_all_timepoints\all_virus_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de-DE" sz="2000" dirty="0">
                <a:solidFill>
                  <a:schemeClr val="tx1"/>
                </a:solidFill>
              </a:rPr>
              <a:t>Presence</a:t>
            </a:r>
            <a:r>
              <a:rPr lang="de-DE" sz="2000" baseline="0" dirty="0">
                <a:solidFill>
                  <a:schemeClr val="tx1"/>
                </a:solidFill>
              </a:rPr>
              <a:t> </a:t>
            </a:r>
            <a:r>
              <a:rPr lang="de-DE" sz="2000" baseline="0" dirty="0" err="1">
                <a:solidFill>
                  <a:schemeClr val="tx1"/>
                </a:solidFill>
              </a:rPr>
              <a:t>of</a:t>
            </a:r>
            <a:r>
              <a:rPr lang="de-DE" sz="2000" baseline="0" dirty="0">
                <a:solidFill>
                  <a:schemeClr val="tx1"/>
                </a:solidFill>
              </a:rPr>
              <a:t> </a:t>
            </a:r>
            <a:r>
              <a:rPr lang="de-DE" sz="2000" baseline="0" dirty="0" err="1">
                <a:solidFill>
                  <a:schemeClr val="tx1"/>
                </a:solidFill>
              </a:rPr>
              <a:t>virus</a:t>
            </a:r>
            <a:r>
              <a:rPr lang="de-DE" sz="2000" baseline="0" dirty="0">
                <a:solidFill>
                  <a:schemeClr val="tx1"/>
                </a:solidFill>
              </a:rPr>
              <a:t> </a:t>
            </a:r>
            <a:r>
              <a:rPr lang="de-DE" sz="2000" baseline="0" dirty="0" err="1">
                <a:solidFill>
                  <a:schemeClr val="tx1"/>
                </a:solidFill>
              </a:rPr>
              <a:t>transcripts</a:t>
            </a:r>
            <a:r>
              <a:rPr lang="de-DE" sz="2000" baseline="0" dirty="0">
                <a:solidFill>
                  <a:schemeClr val="tx1"/>
                </a:solidFill>
              </a:rPr>
              <a:t> in % </a:t>
            </a:r>
            <a:r>
              <a:rPr lang="de-DE" sz="2000" baseline="0" dirty="0" err="1">
                <a:solidFill>
                  <a:schemeClr val="tx1"/>
                </a:solidFill>
              </a:rPr>
              <a:t>of</a:t>
            </a:r>
            <a:r>
              <a:rPr lang="de-DE" sz="2000" baseline="0" dirty="0">
                <a:solidFill>
                  <a:schemeClr val="tx1"/>
                </a:solidFill>
              </a:rPr>
              <a:t> </a:t>
            </a:r>
            <a:r>
              <a:rPr lang="de-DE" sz="2000" baseline="0" dirty="0" err="1">
                <a:solidFill>
                  <a:schemeClr val="tx1"/>
                </a:solidFill>
              </a:rPr>
              <a:t>analysed</a:t>
            </a:r>
            <a:r>
              <a:rPr lang="de-DE" sz="2000" baseline="0" dirty="0">
                <a:solidFill>
                  <a:schemeClr val="tx1"/>
                </a:solidFill>
              </a:rPr>
              <a:t> </a:t>
            </a:r>
            <a:r>
              <a:rPr lang="en-GB" sz="2000" baseline="0" noProof="0" dirty="0">
                <a:solidFill>
                  <a:schemeClr val="tx1"/>
                </a:solidFill>
              </a:rPr>
              <a:t>individuals</a:t>
            </a:r>
            <a:endParaRPr lang="en-GB" sz="2000" noProof="0" dirty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4.4979670679666378E-2"/>
          <c:y val="2.83108406666665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0814454951854777"/>
          <c:y val="0.14621702716805182"/>
          <c:w val="0.84008461920049493"/>
          <c:h val="0.630820313807711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nly_existence!$AO$12</c:f>
              <c:strCache>
                <c:ptCount val="1"/>
                <c:pt idx="0">
                  <c:v>good</c:v>
                </c:pt>
              </c:strCache>
            </c:strRef>
          </c:tx>
          <c:spPr>
            <a:solidFill>
              <a:srgbClr val="B3CA81"/>
            </a:solidFill>
            <a:ln>
              <a:solidFill>
                <a:srgbClr val="B3CA81"/>
              </a:solidFill>
            </a:ln>
            <a:effectLst/>
          </c:spPr>
          <c:invertIfNegative val="0"/>
          <c:cat>
            <c:strRef>
              <c:f>only_existence!$AN$13:$AN$17</c:f>
              <c:strCache>
                <c:ptCount val="5"/>
                <c:pt idx="0">
                  <c:v>Beet cryptic virus 2</c:v>
                </c:pt>
                <c:pt idx="1">
                  <c:v>Beet necrotic yellow vein virus</c:v>
                </c:pt>
                <c:pt idx="2">
                  <c:v>Beet virus Q</c:v>
                </c:pt>
                <c:pt idx="3">
                  <c:v>Beta vulgaris mitovirus 1</c:v>
                </c:pt>
                <c:pt idx="4">
                  <c:v>Melon chlorotic spot virus</c:v>
                </c:pt>
              </c:strCache>
            </c:strRef>
          </c:cat>
          <c:val>
            <c:numRef>
              <c:f>only_existence!$AO$13:$AO$17</c:f>
              <c:numCache>
                <c:formatCode>General</c:formatCode>
                <c:ptCount val="5"/>
                <c:pt idx="0">
                  <c:v>46.666666666666671</c:v>
                </c:pt>
                <c:pt idx="1">
                  <c:v>26.666666666666668</c:v>
                </c:pt>
                <c:pt idx="2">
                  <c:v>16.666666666666668</c:v>
                </c:pt>
                <c:pt idx="3">
                  <c:v>96.666666666666671</c:v>
                </c:pt>
                <c:pt idx="4">
                  <c:v>3.33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0E-43C8-A3D3-D12D621BB8EF}"/>
            </c:ext>
          </c:extLst>
        </c:ser>
        <c:ser>
          <c:idx val="1"/>
          <c:order val="1"/>
          <c:tx>
            <c:strRef>
              <c:f>only_existence!$AP$12</c:f>
              <c:strCache>
                <c:ptCount val="1"/>
                <c:pt idx="0">
                  <c:v>moderate</c:v>
                </c:pt>
              </c:strCache>
            </c:strRef>
          </c:tx>
          <c:spPr>
            <a:solidFill>
              <a:srgbClr val="FFB260"/>
            </a:solidFill>
            <a:ln>
              <a:solidFill>
                <a:srgbClr val="FFB260"/>
              </a:solidFill>
            </a:ln>
            <a:effectLst/>
          </c:spPr>
          <c:invertIfNegative val="0"/>
          <c:cat>
            <c:strRef>
              <c:f>only_existence!$AN$13:$AN$17</c:f>
              <c:strCache>
                <c:ptCount val="5"/>
                <c:pt idx="0">
                  <c:v>Beet cryptic virus 2</c:v>
                </c:pt>
                <c:pt idx="1">
                  <c:v>Beet necrotic yellow vein virus</c:v>
                </c:pt>
                <c:pt idx="2">
                  <c:v>Beet virus Q</c:v>
                </c:pt>
                <c:pt idx="3">
                  <c:v>Beta vulgaris mitovirus 1</c:v>
                </c:pt>
                <c:pt idx="4">
                  <c:v>Melon chlorotic spot virus</c:v>
                </c:pt>
              </c:strCache>
            </c:strRef>
          </c:cat>
          <c:val>
            <c:numRef>
              <c:f>only_existence!$AP$13:$AP$17</c:f>
              <c:numCache>
                <c:formatCode>General</c:formatCode>
                <c:ptCount val="5"/>
                <c:pt idx="0">
                  <c:v>56.666666666666671</c:v>
                </c:pt>
                <c:pt idx="1">
                  <c:v>33.333333333333336</c:v>
                </c:pt>
                <c:pt idx="2">
                  <c:v>16.666666666666668</c:v>
                </c:pt>
                <c:pt idx="3">
                  <c:v>10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20E-43C8-A3D3-D12D621BB8EF}"/>
            </c:ext>
          </c:extLst>
        </c:ser>
        <c:ser>
          <c:idx val="2"/>
          <c:order val="2"/>
          <c:tx>
            <c:strRef>
              <c:f>only_existence!$AQ$12</c:f>
              <c:strCache>
                <c:ptCount val="1"/>
                <c:pt idx="0">
                  <c:v>bad</c:v>
                </c:pt>
              </c:strCache>
            </c:strRef>
          </c:tx>
          <c:spPr>
            <a:solidFill>
              <a:srgbClr val="573A64"/>
            </a:solidFill>
            <a:ln>
              <a:solidFill>
                <a:srgbClr val="B3CA8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573A64"/>
              </a:solidFill>
              <a:ln>
                <a:solidFill>
                  <a:srgbClr val="573A64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96AD-4366-98BE-59271715066E}"/>
              </c:ext>
            </c:extLst>
          </c:dPt>
          <c:cat>
            <c:strRef>
              <c:f>only_existence!$AN$13:$AN$17</c:f>
              <c:strCache>
                <c:ptCount val="5"/>
                <c:pt idx="0">
                  <c:v>Beet cryptic virus 2</c:v>
                </c:pt>
                <c:pt idx="1">
                  <c:v>Beet necrotic yellow vein virus</c:v>
                </c:pt>
                <c:pt idx="2">
                  <c:v>Beet virus Q</c:v>
                </c:pt>
                <c:pt idx="3">
                  <c:v>Beta vulgaris mitovirus 1</c:v>
                </c:pt>
                <c:pt idx="4">
                  <c:v>Melon chlorotic spot virus</c:v>
                </c:pt>
              </c:strCache>
            </c:strRef>
          </c:cat>
          <c:val>
            <c:numRef>
              <c:f>only_existence!$AQ$13:$AQ$17</c:f>
              <c:numCache>
                <c:formatCode>General</c:formatCode>
                <c:ptCount val="5"/>
                <c:pt idx="0">
                  <c:v>93.333333333333343</c:v>
                </c:pt>
                <c:pt idx="1">
                  <c:v>33.333333333333336</c:v>
                </c:pt>
                <c:pt idx="2">
                  <c:v>23.333333333333336</c:v>
                </c:pt>
                <c:pt idx="3">
                  <c:v>100</c:v>
                </c:pt>
                <c:pt idx="4">
                  <c:v>3.33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20E-43C8-A3D3-D12D621BB8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82057744"/>
        <c:axId val="482060040"/>
      </c:barChart>
      <c:catAx>
        <c:axId val="4820577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82060040"/>
        <c:crosses val="autoZero"/>
        <c:auto val="1"/>
        <c:lblAlgn val="ctr"/>
        <c:lblOffset val="100"/>
        <c:noMultiLvlLbl val="0"/>
      </c:catAx>
      <c:valAx>
        <c:axId val="482060040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800">
                    <a:solidFill>
                      <a:schemeClr val="tx1"/>
                    </a:solidFill>
                  </a:rPr>
                  <a:t>#</a:t>
                </a:r>
                <a:r>
                  <a:rPr lang="de-DE" sz="1800" baseline="0">
                    <a:solidFill>
                      <a:schemeClr val="tx1"/>
                    </a:solidFill>
                  </a:rPr>
                  <a:t> individuals (%)</a:t>
                </a:r>
                <a:endParaRPr lang="de-DE" sz="180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820577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597746173263009"/>
          <c:y val="0.94360547423896313"/>
          <c:w val="0.25762831163711036"/>
          <c:h val="5.63945257610368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6C04B4E-710C-4775-97A7-5FA2204913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5A8B7440-F974-45AF-9CB3-64E875CE2D0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FBFE0F8-C1CD-4316-AAE3-B97EA63FF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8D7A4CF-0D0A-4246-8CAB-0D144CC9F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76CFDC-A88B-4B1A-8010-57BE21E93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4166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3741EEC-B094-413A-977B-14E251189A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1BE5214-5C67-4FD0-B348-C4B75F5CDA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71C0AAC-1779-4C14-828E-11C2F8DF2A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7CE241A-4950-4FB2-A99F-2D88780BC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6FD356B-C449-4D80-BA6F-CFE84DB408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880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C7B9F9A-9ECE-4003-B449-743D7236BB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94CF6F3-682F-41BE-8ECD-93A2D23E92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4226CFB-83B9-4EB2-988B-53F4E6437D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3AC5F50-E5EA-435E-A2B6-16BCBE9FA9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957FF7F-5682-410F-919E-65BC1ADB0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5756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5A77B1-4DEB-4910-944D-B220BA66E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5C29B09-9DFA-47B5-A68E-F91201EAF1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41DDAF-191A-4C75-810A-06A37526B0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8730E5F-7EB9-48E9-AD82-3FC40D3F2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514D0F3-9F44-487F-8EDF-458E2DAE7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176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A2CA9F8-8392-493B-9A80-C1410A1072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8F60F28-CD5A-46A0-A478-917C97D710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730B36A-59CF-47DA-9552-343A49404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1FF2DF3-EC8F-42BD-904E-ECEE40C75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EC10EAC-1154-4348-947E-530101534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2432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7D65E1E-B5C5-45A7-A068-75C540F866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96B7FCA-C567-4C6C-8CB1-8CF920018F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0A263EA-4AF7-4248-95ED-6D36EFD7DC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90A72F2-B6DD-4F91-9177-251A18D1D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EFDCAA7-4A62-45E0-8C82-C14748184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03E6553-3CB6-48C3-82B6-35BEE0E5A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548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FB12B9-2957-49F3-936A-7123AD1C3E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AA96037-8912-4E19-8113-2FAD0BE816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3C122D7A-1CCC-4EA2-A318-8625C0F63E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26A554E-472E-4481-ADE1-03A9B18F08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4AB5414-59BB-431D-AF28-236E6AF079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12AA618-FE51-4385-BF10-18F57EA9E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3328F25-07A6-4DEA-A35D-880E4344C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107257C-7BC3-4EC1-A414-0FA74D589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199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F088D1-9094-498C-84FF-4D2216F34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C04FB0E-CE70-4C7D-BCF5-DFAA431E18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51E5B62-9157-4A90-90C9-FD7F24BFF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7B12CAB-9223-42C1-984B-74582AAF60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920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17DECE7-D406-4343-AC6E-ECA87581CA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186B1B1-48BD-4BD7-8B37-39470B8FD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0A0A9AB-1E56-4F7C-BDAB-B15A9CB04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4739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1C36F2-E5FD-4760-8DE1-5735C94E6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E5CF45D-0193-4EED-A5A8-D28A6C0558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87DA792-A158-46D7-A06A-AE6BD2634C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760A488-E165-48BB-BCD2-B33FDA8CC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6C2918D-5555-4FD2-82FE-64CCE4D12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A5D1514-632A-4E18-8261-6D91382219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7195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FEE541-4CCE-43E0-A8A8-36D0EAF6DC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5049C91B-AF41-4A59-91E4-8C3F21834D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4364499-E8CC-452B-A3F4-6B2E3284D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945A462-230D-4F23-8071-BC348DA4B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781920E-304B-4D13-8B73-F99014940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0FB5AE-85CE-4A3E-850B-AF4A51729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9651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B88F9F6-8B6F-46B9-B859-A0A0549A42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8A3B8C-45B5-4966-BCA5-F363C3B22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50ECFFD-2062-4A42-9A62-8E5DFF562EA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498DC2-1AFC-453F-9625-6A12DCA95A79}" type="datetimeFigureOut">
              <a:rPr lang="en-GB" smtClean="0"/>
              <a:t>02/03/2020</a:t>
            </a:fld>
            <a:endParaRPr lang="en-GB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FC1DA33-7D4B-4615-AA29-6666771CAA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AB99A1C-688C-4301-9216-17EEB91803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37603-84C9-4BF7-96B4-F9A8C8FD283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7902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3">
            <a:extLst>
              <a:ext uri="{FF2B5EF4-FFF2-40B4-BE49-F238E27FC236}">
                <a16:creationId xmlns:a16="http://schemas.microsoft.com/office/drawing/2014/main" id="{35BF7959-8092-4999-B304-D0601B1DB6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9831992"/>
              </p:ext>
            </p:extLst>
          </p:nvPr>
        </p:nvGraphicFramePr>
        <p:xfrm>
          <a:off x="850004" y="576329"/>
          <a:ext cx="10303099" cy="57053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45645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ritsch Silvia</dc:creator>
  <cp:lastModifiedBy>Madritsch Silvia</cp:lastModifiedBy>
  <cp:revision>3</cp:revision>
  <dcterms:created xsi:type="dcterms:W3CDTF">2020-02-20T12:10:15Z</dcterms:created>
  <dcterms:modified xsi:type="dcterms:W3CDTF">2020-03-02T10:17:03Z</dcterms:modified>
</cp:coreProperties>
</file>